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 showGuides="1">
      <p:cViewPr varScale="1">
        <p:scale>
          <a:sx n="86" d="100"/>
          <a:sy n="86" d="100"/>
        </p:scale>
        <p:origin x="3456" y="2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604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043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65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413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5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659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873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197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5930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617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010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60CF4-350E-3C44-98A4-1EEDC77BB09D}" type="datetimeFigureOut">
              <a:rPr lang="en-US" smtClean="0"/>
              <a:t>12/2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64F4E6-826A-3E4A-BC9C-9D21D323D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3808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9986" y="5925128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ovie 1: Balance disorder of 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rod1CKO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</a:t>
            </a:r>
            <a:r>
              <a:rPr lang="en-GB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rod1CKO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(the white mouse, genotype: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g1</a:t>
            </a:r>
            <a:r>
              <a:rPr lang="en-GB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/+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eurod1</a:t>
            </a:r>
            <a:r>
              <a:rPr lang="en-GB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xP/</a:t>
            </a:r>
            <a:r>
              <a:rPr lang="en-GB" sz="1200" i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x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has severe balance problems, wobbles from side to side compared to the control littermate (agouti).</a:t>
            </a:r>
          </a:p>
        </p:txBody>
      </p:sp>
      <p:pic>
        <p:nvPicPr>
          <p:cNvPr id="4" name="No sound 480" descr="No sound 480">
            <a:hlinkClick r:id="" action="ppaction://media"/>
            <a:extLst>
              <a:ext uri="{FF2B5EF4-FFF2-40B4-BE49-F238E27FC236}">
                <a16:creationId xmlns:a16="http://schemas.microsoft.com/office/drawing/2014/main" id="{96247BDD-4F89-684B-8AA7-32127B27B44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1113" y="3175"/>
            <a:ext cx="6858000" cy="3857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560706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29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43</Words>
  <Application>Microsoft Macintosh PowerPoint</Application>
  <PresentationFormat>A4 Paper (210x297 mm)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línková Gabriela</dc:creator>
  <cp:lastModifiedBy>Pavlínková Gabriela</cp:lastModifiedBy>
  <cp:revision>2</cp:revision>
  <dcterms:created xsi:type="dcterms:W3CDTF">2021-12-29T08:49:04Z</dcterms:created>
  <dcterms:modified xsi:type="dcterms:W3CDTF">2021-12-29T09:08:27Z</dcterms:modified>
</cp:coreProperties>
</file>